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CA45C-E0E2-4FB2-9D44-F2AA8FAC51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306C4-B7DB-4A3D-94B1-2421922C5F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42FCA7-F9CD-44FF-8ECE-B5B0517D13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E5A6E3-D50A-4D65-8568-0955B4DDFB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B1269-3242-4E90-A97D-D496F84913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9715E-FC16-4583-A709-59C1EC37B8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DBDFF-7C51-445F-8FE2-12C8FFA086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062FA1-5777-4AF6-A47A-3A5C5FBB80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563B3-280E-4980-96D5-4C0873B398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CF2D1-0C53-4A36-9E1A-3447DE19BA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0E3F2-2493-4470-8FFB-F29AFBF5B6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2C153-EFAE-4A10-86C3-64CC7700CE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38DAC2-9647-46B9-924D-1C741E6AE10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127800" y="333000"/>
            <a:ext cx="738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0A. Correlation plots for MAQC2 gene level brain data set using procedure 1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3" descr=""/>
          <p:cNvPicPr/>
          <p:nvPr/>
        </p:nvPicPr>
        <p:blipFill>
          <a:blip r:embed="rId1"/>
          <a:stretch/>
        </p:blipFill>
        <p:spPr>
          <a:xfrm>
            <a:off x="1692360" y="685800"/>
            <a:ext cx="5759280" cy="569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Rectangle 1"/>
          <p:cNvSpPr/>
          <p:nvPr/>
        </p:nvSpPr>
        <p:spPr>
          <a:xfrm>
            <a:off x="129240" y="260640"/>
            <a:ext cx="7261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0B. Correlation plotsfor MAQC2 gene level UHR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8"/>
          <p:cNvSpPr/>
          <p:nvPr/>
        </p:nvSpPr>
        <p:spPr>
          <a:xfrm>
            <a:off x="2268360" y="1281240"/>
            <a:ext cx="3589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2" descr=""/>
          <p:cNvPicPr/>
          <p:nvPr/>
        </p:nvPicPr>
        <p:blipFill>
          <a:blip r:embed="rId1"/>
          <a:stretch/>
        </p:blipFill>
        <p:spPr>
          <a:xfrm>
            <a:off x="1692360" y="581040"/>
            <a:ext cx="5759280" cy="569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Rectangle 1"/>
          <p:cNvSpPr/>
          <p:nvPr/>
        </p:nvSpPr>
        <p:spPr>
          <a:xfrm>
            <a:off x="122040" y="168480"/>
            <a:ext cx="6458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0C. Correlation plots for Marioni liver data set using procedure 2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ectangle 7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1660680" y="581040"/>
            <a:ext cx="5822640" cy="569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1"/>
          <p:cNvSpPr/>
          <p:nvPr/>
        </p:nvSpPr>
        <p:spPr>
          <a:xfrm>
            <a:off x="123840" y="260640"/>
            <a:ext cx="6625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0D. Correlation plots for Marioni kidney data set using procedure 2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8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2" descr=""/>
          <p:cNvPicPr/>
          <p:nvPr/>
        </p:nvPicPr>
        <p:blipFill>
          <a:blip r:embed="rId1"/>
          <a:stretch/>
        </p:blipFill>
        <p:spPr>
          <a:xfrm>
            <a:off x="1673280" y="581040"/>
            <a:ext cx="5797440" cy="569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1"/>
          <p:cNvSpPr/>
          <p:nvPr/>
        </p:nvSpPr>
        <p:spPr>
          <a:xfrm>
            <a:off x="112680" y="189360"/>
            <a:ext cx="612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0E. Correlation plots for FRT-Seq data set using procedure 2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11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2" descr=""/>
          <p:cNvPicPr/>
          <p:nvPr/>
        </p:nvPicPr>
        <p:blipFill>
          <a:blip r:embed="rId1"/>
          <a:stretch/>
        </p:blipFill>
        <p:spPr>
          <a:xfrm>
            <a:off x="1692360" y="581040"/>
            <a:ext cx="5759280" cy="569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Rectangle 1"/>
          <p:cNvSpPr/>
          <p:nvPr/>
        </p:nvSpPr>
        <p:spPr>
          <a:xfrm>
            <a:off x="115200" y="333000"/>
            <a:ext cx="6308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0F. Correlation plots for Lee35 yeast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11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2" descr=""/>
          <p:cNvPicPr/>
          <p:nvPr/>
        </p:nvPicPr>
        <p:blipFill>
          <a:blip r:embed="rId1"/>
          <a:stretch/>
        </p:blipFill>
        <p:spPr>
          <a:xfrm>
            <a:off x="1679400" y="828720"/>
            <a:ext cx="5785200" cy="569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Rectangle 1"/>
          <p:cNvSpPr/>
          <p:nvPr/>
        </p:nvSpPr>
        <p:spPr>
          <a:xfrm>
            <a:off x="122040" y="116280"/>
            <a:ext cx="756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0G. Correlation plots for Nagalakshmi oligo dT yeast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8"/>
          <p:cNvSpPr/>
          <p:nvPr/>
        </p:nvSpPr>
        <p:spPr>
          <a:xfrm>
            <a:off x="2268360" y="1268280"/>
            <a:ext cx="35892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3" descr=""/>
          <p:cNvPicPr/>
          <p:nvPr/>
        </p:nvPicPr>
        <p:blipFill>
          <a:blip r:embed="rId1"/>
          <a:stretch/>
        </p:blipFill>
        <p:spPr>
          <a:xfrm>
            <a:off x="1654200" y="581040"/>
            <a:ext cx="5835600" cy="569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Rectangle 1"/>
          <p:cNvSpPr/>
          <p:nvPr/>
        </p:nvSpPr>
        <p:spPr>
          <a:xfrm>
            <a:off x="104400" y="333000"/>
            <a:ext cx="8244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file 10H. Correlation plots for Nagalakshmi random hexamer yeast data set using procedure 1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8"/>
          <p:cNvSpPr/>
          <p:nvPr/>
        </p:nvSpPr>
        <p:spPr>
          <a:xfrm>
            <a:off x="2124000" y="1268280"/>
            <a:ext cx="36036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Picture 2" descr=""/>
          <p:cNvPicPr/>
          <p:nvPr/>
        </p:nvPicPr>
        <p:blipFill>
          <a:blip r:embed="rId1"/>
          <a:stretch/>
        </p:blipFill>
        <p:spPr>
          <a:xfrm>
            <a:off x="1638360" y="828720"/>
            <a:ext cx="5867280" cy="569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17:29:38Z</dcterms:created>
  <dc:creator>Wei Zheng</dc:creator>
  <dc:description/>
  <dc:language>en-US</dc:language>
  <cp:lastModifiedBy>Wei Zheng</cp:lastModifiedBy>
  <dcterms:modified xsi:type="dcterms:W3CDTF">2011-06-06T17:33:19Z</dcterms:modified>
  <cp:revision>1</cp:revision>
  <dc:subject/>
  <dc:title>Slide 1</dc:title>
</cp:coreProperties>
</file>